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129" autoAdjust="0"/>
    <p:restoredTop sz="94660"/>
  </p:normalViewPr>
  <p:slideViewPr>
    <p:cSldViewPr snapToGrid="0">
      <p:cViewPr varScale="1">
        <p:scale>
          <a:sx n="96" d="100"/>
          <a:sy n="96" d="100"/>
        </p:scale>
        <p:origin x="127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___1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___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331496062992126"/>
          <c:y val="0.1111111111111111"/>
          <c:w val="0.80841907261592305"/>
          <c:h val="0.74753280839895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4!$B$25</c:f>
              <c:strCache>
                <c:ptCount val="1"/>
                <c:pt idx="0">
                  <c:v>Col-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4!$C$26:$C$31</c:f>
                <c:numCache>
                  <c:formatCode>General</c:formatCode>
                  <c:ptCount val="6"/>
                  <c:pt idx="0">
                    <c:v>0.24876813727468483</c:v>
                  </c:pt>
                  <c:pt idx="1">
                    <c:v>0.15903640314331025</c:v>
                  </c:pt>
                  <c:pt idx="2">
                    <c:v>0.14307546261868631</c:v>
                  </c:pt>
                  <c:pt idx="3">
                    <c:v>0.1152431913327312</c:v>
                  </c:pt>
                  <c:pt idx="4">
                    <c:v>6.3285140144229812E-2</c:v>
                  </c:pt>
                  <c:pt idx="5">
                    <c:v>0.10960168754314159</c:v>
                  </c:pt>
                </c:numCache>
              </c:numRef>
            </c:plus>
            <c:minus>
              <c:numRef>
                <c:f>Sheet4!$C$26:$C$31</c:f>
                <c:numCache>
                  <c:formatCode>General</c:formatCode>
                  <c:ptCount val="6"/>
                  <c:pt idx="0">
                    <c:v>0.24876813727468483</c:v>
                  </c:pt>
                  <c:pt idx="1">
                    <c:v>0.15903640314331025</c:v>
                  </c:pt>
                  <c:pt idx="2">
                    <c:v>0.14307546261868631</c:v>
                  </c:pt>
                  <c:pt idx="3">
                    <c:v>0.1152431913327312</c:v>
                  </c:pt>
                  <c:pt idx="4">
                    <c:v>6.3285140144229812E-2</c:v>
                  </c:pt>
                  <c:pt idx="5">
                    <c:v>0.109601687543141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4!$A$26:$A$31</c:f>
              <c:strCache>
                <c:ptCount val="6"/>
                <c:pt idx="0">
                  <c:v>GA2ox1</c:v>
                </c:pt>
                <c:pt idx="1">
                  <c:v>GA2ox2</c:v>
                </c:pt>
                <c:pt idx="2">
                  <c:v>GA2ox4</c:v>
                </c:pt>
                <c:pt idx="3">
                  <c:v>GAI</c:v>
                </c:pt>
                <c:pt idx="4">
                  <c:v>RGL2</c:v>
                </c:pt>
                <c:pt idx="5">
                  <c:v>RGL3</c:v>
                </c:pt>
              </c:strCache>
            </c:strRef>
          </c:cat>
          <c:val>
            <c:numRef>
              <c:f>Sheet4!$B$26:$B$31</c:f>
              <c:numCache>
                <c:formatCode>General</c:formatCode>
                <c:ptCount val="6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4!$E$25</c:f>
              <c:strCache>
                <c:ptCount val="1"/>
                <c:pt idx="0">
                  <c:v>ref6-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4!$G$26:$G$31</c:f>
                <c:numCache>
                  <c:formatCode>General</c:formatCode>
                  <c:ptCount val="6"/>
                  <c:pt idx="0">
                    <c:v>3.9348432736379024</c:v>
                  </c:pt>
                  <c:pt idx="1">
                    <c:v>1.4189954847317949</c:v>
                  </c:pt>
                  <c:pt idx="2">
                    <c:v>4.6475887705810983</c:v>
                  </c:pt>
                  <c:pt idx="3">
                    <c:v>0.7787595693075815</c:v>
                  </c:pt>
                  <c:pt idx="4">
                    <c:v>1.8530220892593352</c:v>
                  </c:pt>
                  <c:pt idx="5">
                    <c:v>4.5642685709080499</c:v>
                  </c:pt>
                </c:numCache>
              </c:numRef>
            </c:plus>
            <c:minus>
              <c:numRef>
                <c:f>Sheet4!$G$26:$G$31</c:f>
                <c:numCache>
                  <c:formatCode>General</c:formatCode>
                  <c:ptCount val="6"/>
                  <c:pt idx="0">
                    <c:v>3.9348432736379024</c:v>
                  </c:pt>
                  <c:pt idx="1">
                    <c:v>1.4189954847317949</c:v>
                  </c:pt>
                  <c:pt idx="2">
                    <c:v>4.6475887705810983</c:v>
                  </c:pt>
                  <c:pt idx="3">
                    <c:v>0.7787595693075815</c:v>
                  </c:pt>
                  <c:pt idx="4">
                    <c:v>1.8530220892593352</c:v>
                  </c:pt>
                  <c:pt idx="5">
                    <c:v>4.56426857090804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4!$A$26:$A$31</c:f>
              <c:strCache>
                <c:ptCount val="6"/>
                <c:pt idx="0">
                  <c:v>GA2ox1</c:v>
                </c:pt>
                <c:pt idx="1">
                  <c:v>GA2ox2</c:v>
                </c:pt>
                <c:pt idx="2">
                  <c:v>GA2ox4</c:v>
                </c:pt>
                <c:pt idx="3">
                  <c:v>GAI</c:v>
                </c:pt>
                <c:pt idx="4">
                  <c:v>RGL2</c:v>
                </c:pt>
                <c:pt idx="5">
                  <c:v>RGL3</c:v>
                </c:pt>
              </c:strCache>
            </c:strRef>
          </c:cat>
          <c:val>
            <c:numRef>
              <c:f>Sheet4!$E$26:$E$31</c:f>
              <c:numCache>
                <c:formatCode>General</c:formatCode>
                <c:ptCount val="6"/>
                <c:pt idx="0">
                  <c:v>17.436334346266513</c:v>
                </c:pt>
                <c:pt idx="1">
                  <c:v>12.090007038044471</c:v>
                </c:pt>
                <c:pt idx="2">
                  <c:v>29.599692838032691</c:v>
                </c:pt>
                <c:pt idx="3">
                  <c:v>6.8673055155195897</c:v>
                </c:pt>
                <c:pt idx="4">
                  <c:v>8.6224282307950855</c:v>
                </c:pt>
                <c:pt idx="5">
                  <c:v>20.1348269800101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586212784"/>
        <c:axId val="-586212240"/>
      </c:barChart>
      <c:catAx>
        <c:axId val="-5862127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586212240"/>
        <c:crosses val="autoZero"/>
        <c:auto val="1"/>
        <c:lblAlgn val="ctr"/>
        <c:lblOffset val="100"/>
        <c:noMultiLvlLbl val="0"/>
      </c:catAx>
      <c:valAx>
        <c:axId val="-5862122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Relative gene expression</a:t>
                </a:r>
                <a:endParaRPr lang="zh-CN" altLang="en-US"/>
              </a:p>
            </c:rich>
          </c:tx>
          <c:layout>
            <c:manualLayout>
              <c:xMode val="edge"/>
              <c:yMode val="edge"/>
              <c:x val="2.1972222222222223E-2"/>
              <c:y val="0.146914552347623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586212784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4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</c:legendEntry>
      <c:layout>
        <c:manualLayout>
          <c:xMode val="edge"/>
          <c:yMode val="edge"/>
          <c:x val="0.42899168853893266"/>
          <c:y val="3.2985564304461944E-2"/>
          <c:w val="0.31479068241469815"/>
          <c:h val="0.1061063721201516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solidFill>
        <a:sysClr val="windowText" lastClr="000000"/>
      </a:solidFill>
    </a:ln>
    <a:effectLst/>
  </c:spPr>
  <c:txPr>
    <a:bodyPr/>
    <a:lstStyle/>
    <a:p>
      <a:pPr>
        <a:defRPr sz="1400">
          <a:latin typeface="+mn-lt"/>
        </a:defRPr>
      </a:pPr>
      <a:endParaRPr lang="zh-CN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6331496062992126"/>
          <c:y val="0.1111111111111111"/>
          <c:w val="0.80841907261592305"/>
          <c:h val="0.74753280839895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4!$B$25</c:f>
              <c:strCache>
                <c:ptCount val="1"/>
                <c:pt idx="0">
                  <c:v>Col-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4!$D$32:$D$37</c:f>
                <c:numCache>
                  <c:formatCode>General</c:formatCode>
                  <c:ptCount val="6"/>
                  <c:pt idx="0">
                    <c:v>0.13618310080612683</c:v>
                  </c:pt>
                  <c:pt idx="1">
                    <c:v>7.2634344810818985E-2</c:v>
                  </c:pt>
                  <c:pt idx="2">
                    <c:v>0.1265733552370939</c:v>
                  </c:pt>
                  <c:pt idx="3">
                    <c:v>8.5646167865861211E-2</c:v>
                  </c:pt>
                  <c:pt idx="4">
                    <c:v>7.0355746826220589E-2</c:v>
                  </c:pt>
                </c:numCache>
              </c:numRef>
            </c:plus>
            <c:minus>
              <c:numRef>
                <c:f>Sheet4!$D$32:$D$37</c:f>
                <c:numCache>
                  <c:formatCode>General</c:formatCode>
                  <c:ptCount val="6"/>
                  <c:pt idx="0">
                    <c:v>0.13618310080612683</c:v>
                  </c:pt>
                  <c:pt idx="1">
                    <c:v>7.2634344810818985E-2</c:v>
                  </c:pt>
                  <c:pt idx="2">
                    <c:v>0.1265733552370939</c:v>
                  </c:pt>
                  <c:pt idx="3">
                    <c:v>8.5646167865861211E-2</c:v>
                  </c:pt>
                  <c:pt idx="4">
                    <c:v>7.035574682622058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4!$A$32:$A$36</c:f>
              <c:strCache>
                <c:ptCount val="5"/>
                <c:pt idx="0">
                  <c:v>ABA1</c:v>
                </c:pt>
                <c:pt idx="1">
                  <c:v>ABA3</c:v>
                </c:pt>
                <c:pt idx="2">
                  <c:v>NCED6</c:v>
                </c:pt>
                <c:pt idx="3">
                  <c:v>ABI3</c:v>
                </c:pt>
                <c:pt idx="4">
                  <c:v>ABI4</c:v>
                </c:pt>
              </c:strCache>
            </c:strRef>
          </c:cat>
          <c:val>
            <c:numRef>
              <c:f>Sheet4!$B$32:$B$36</c:f>
              <c:numCache>
                <c:formatCode>General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4!$E$25</c:f>
              <c:strCache>
                <c:ptCount val="1"/>
                <c:pt idx="0">
                  <c:v>ref6-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4!$G$32:$G$37</c:f>
                <c:numCache>
                  <c:formatCode>General</c:formatCode>
                  <c:ptCount val="6"/>
                  <c:pt idx="0">
                    <c:v>1.1166127116636133</c:v>
                  </c:pt>
                  <c:pt idx="1">
                    <c:v>2.0024426337968535</c:v>
                  </c:pt>
                  <c:pt idx="2">
                    <c:v>6.4426632031265996</c:v>
                  </c:pt>
                  <c:pt idx="3">
                    <c:v>0.51609802405588612</c:v>
                  </c:pt>
                  <c:pt idx="4">
                    <c:v>0.55376122484897605</c:v>
                  </c:pt>
                </c:numCache>
              </c:numRef>
            </c:plus>
            <c:minus>
              <c:numRef>
                <c:f>Sheet4!$G$32:$G$37</c:f>
                <c:numCache>
                  <c:formatCode>General</c:formatCode>
                  <c:ptCount val="6"/>
                  <c:pt idx="0">
                    <c:v>1.1166127116636133</c:v>
                  </c:pt>
                  <c:pt idx="1">
                    <c:v>2.0024426337968535</c:v>
                  </c:pt>
                  <c:pt idx="2">
                    <c:v>6.4426632031265996</c:v>
                  </c:pt>
                  <c:pt idx="3">
                    <c:v>0.51609802405588612</c:v>
                  </c:pt>
                  <c:pt idx="4">
                    <c:v>0.553761224848976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4!$A$32:$A$36</c:f>
              <c:strCache>
                <c:ptCount val="5"/>
                <c:pt idx="0">
                  <c:v>ABA1</c:v>
                </c:pt>
                <c:pt idx="1">
                  <c:v>ABA3</c:v>
                </c:pt>
                <c:pt idx="2">
                  <c:v>NCED6</c:v>
                </c:pt>
                <c:pt idx="3">
                  <c:v>ABI3</c:v>
                </c:pt>
                <c:pt idx="4">
                  <c:v>ABI4</c:v>
                </c:pt>
              </c:strCache>
            </c:strRef>
          </c:cat>
          <c:val>
            <c:numRef>
              <c:f>Sheet4!$E$32:$E$36</c:f>
              <c:numCache>
                <c:formatCode>General</c:formatCode>
                <c:ptCount val="5"/>
                <c:pt idx="0">
                  <c:v>12.665912818315174</c:v>
                </c:pt>
                <c:pt idx="1">
                  <c:v>22.257480434484524</c:v>
                </c:pt>
                <c:pt idx="2">
                  <c:v>37.051342561096888</c:v>
                </c:pt>
                <c:pt idx="3">
                  <c:v>2.7543618093140889</c:v>
                </c:pt>
                <c:pt idx="4">
                  <c:v>2.52143446433535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488143728"/>
        <c:axId val="-488139920"/>
      </c:barChart>
      <c:catAx>
        <c:axId val="-48814372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488139920"/>
        <c:crosses val="autoZero"/>
        <c:auto val="1"/>
        <c:lblAlgn val="ctr"/>
        <c:lblOffset val="100"/>
        <c:noMultiLvlLbl val="0"/>
      </c:catAx>
      <c:valAx>
        <c:axId val="-4881399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Relative gene expression</a:t>
                </a:r>
                <a:endParaRPr lang="zh-CN" altLang="en-US"/>
              </a:p>
            </c:rich>
          </c:tx>
          <c:layout>
            <c:manualLayout>
              <c:xMode val="edge"/>
              <c:yMode val="edge"/>
              <c:x val="2.1972222222222223E-2"/>
              <c:y val="0.146914552347623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-4881437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4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</c:legendEntry>
      <c:layout>
        <c:manualLayout>
          <c:xMode val="edge"/>
          <c:yMode val="edge"/>
          <c:x val="0.45676946631671034"/>
          <c:y val="1.9096675415573052E-2"/>
          <c:w val="0.31599081364829396"/>
          <c:h val="0.1061063721201516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solidFill>
        <a:sysClr val="windowText" lastClr="000000"/>
      </a:solidFill>
    </a:ln>
    <a:effectLst/>
  </c:spPr>
  <c:txPr>
    <a:bodyPr/>
    <a:lstStyle/>
    <a:p>
      <a:pPr>
        <a:defRPr sz="1400">
          <a:latin typeface="+mn-lt"/>
        </a:defRPr>
      </a:pPr>
      <a:endParaRPr lang="zh-CN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1178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1057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5950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9423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4400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9879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4832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9557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6924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39948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1824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035426-E4F3-48B0-9ABD-9305548946B2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7F3B8E-0CAA-4E94-A0BF-C38AAA5337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24849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/>
          <p:cNvGrpSpPr/>
          <p:nvPr/>
        </p:nvGrpSpPr>
        <p:grpSpPr>
          <a:xfrm>
            <a:off x="453224" y="10697"/>
            <a:ext cx="8269357" cy="6746056"/>
            <a:chOff x="453224" y="10697"/>
            <a:chExt cx="8269357" cy="6746056"/>
          </a:xfrm>
        </p:grpSpPr>
        <p:sp>
          <p:nvSpPr>
            <p:cNvPr id="5" name="文本框 4"/>
            <p:cNvSpPr txBox="1"/>
            <p:nvPr/>
          </p:nvSpPr>
          <p:spPr>
            <a:xfrm>
              <a:off x="453224" y="5802646"/>
              <a:ext cx="8269357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 Figure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3. 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6 regulates the expression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ABA 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 signal related genes. 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 qRT-PCR analysis of ABA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gnal related genes in 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6-1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eds </a:t>
              </a:r>
              <a:r>
                <a:rPr lang="en-US" altLang="zh-CN" sz="14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under </a:t>
              </a:r>
              <a:r>
                <a:rPr lang="en-US" altLang="zh-CN" sz="14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R/R conditions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 </a:t>
              </a:r>
              <a:r>
                <a:rPr lang="en-US" altLang="zh-CN" sz="14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RT-PCR analysis of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A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gnal related genes 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 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6-1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eds </a:t>
              </a:r>
              <a:r>
                <a:rPr lang="en-US" altLang="zh-CN" sz="14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under FR/R conditions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P2A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was used as an internal control. Values are shown as means ± SD (**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&lt; 0.01, difference from Col-0, n=3).</a:t>
              </a:r>
            </a:p>
          </p:txBody>
        </p:sp>
        <p:graphicFrame>
          <p:nvGraphicFramePr>
            <p:cNvPr id="4" name="图表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7518538"/>
                </p:ext>
              </p:extLst>
            </p:nvPr>
          </p:nvGraphicFramePr>
          <p:xfrm>
            <a:off x="2736961" y="11406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" name="文本框 1"/>
            <p:cNvSpPr txBox="1"/>
            <p:nvPr/>
          </p:nvSpPr>
          <p:spPr>
            <a:xfrm>
              <a:off x="2290363" y="10697"/>
              <a:ext cx="32893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>
                  <a:latin typeface="+mj-lt"/>
                </a:rPr>
                <a:t>A</a:t>
              </a:r>
              <a:endParaRPr lang="zh-CN" altLang="en-US" sz="2000" dirty="0">
                <a:latin typeface="+mj-lt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2290363" y="2860870"/>
              <a:ext cx="32252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>
                  <a:latin typeface="+mj-lt"/>
                </a:rPr>
                <a:t>B</a:t>
              </a:r>
              <a:endParaRPr lang="zh-CN" altLang="en-US" sz="2000" dirty="0">
                <a:latin typeface="+mj-lt"/>
              </a:endParaRPr>
            </a:p>
          </p:txBody>
        </p:sp>
        <p:graphicFrame>
          <p:nvGraphicFramePr>
            <p:cNvPr id="8" name="图表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24569354"/>
                </p:ext>
              </p:extLst>
            </p:nvPr>
          </p:nvGraphicFramePr>
          <p:xfrm>
            <a:off x="2736961" y="2973977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" name="文本框 2"/>
            <p:cNvSpPr txBox="1"/>
            <p:nvPr/>
          </p:nvSpPr>
          <p:spPr>
            <a:xfrm>
              <a:off x="3697356" y="1152483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/>
                <a:t>**</a:t>
              </a:r>
              <a:endParaRPr lang="zh-CN" altLang="en-US" sz="1400" dirty="0"/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4310932" y="1544435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/>
                <a:t>**</a:t>
              </a:r>
              <a:endParaRPr lang="zh-CN" altLang="en-US" sz="1400" dirty="0"/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4927379" y="493422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/>
                <a:t>**</a:t>
              </a:r>
              <a:endParaRPr lang="zh-CN" altLang="en-US" sz="1400" dirty="0"/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5540900" y="1859395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/>
                <a:t>**</a:t>
              </a:r>
              <a:endParaRPr lang="zh-CN" altLang="en-US" sz="1400" dirty="0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6159610" y="1718643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/>
                <a:t>**</a:t>
              </a:r>
              <a:endParaRPr lang="zh-CN" altLang="en-US" sz="1400" dirty="0"/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6780474" y="980159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/>
                <a:t>**</a:t>
              </a:r>
              <a:endParaRPr lang="zh-CN" altLang="en-US" sz="1400" dirty="0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3770244" y="4521694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/>
                <a:t>**</a:t>
              </a:r>
              <a:endParaRPr lang="zh-CN" altLang="en-US" sz="1400" dirty="0"/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4518433" y="4095564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/>
                <a:t>**</a:t>
              </a:r>
              <a:endParaRPr lang="zh-CN" altLang="en-US" sz="1400" dirty="0"/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5256021" y="3330246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/>
                <a:t>**</a:t>
              </a:r>
              <a:endParaRPr lang="zh-CN" altLang="en-US" sz="1400" dirty="0"/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6729682" y="4997974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/>
                <a:t>**</a:t>
              </a:r>
              <a:endParaRPr lang="zh-CN" altLang="en-US" sz="1400" dirty="0"/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5997829" y="4992894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/>
                <a:t>**</a:t>
              </a:r>
              <a:endParaRPr lang="zh-CN" alt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11920213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3</TotalTime>
  <Words>95</Words>
  <Application>Microsoft Office PowerPoint</Application>
  <PresentationFormat>全屏显示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帐户</dc:creator>
  <cp:lastModifiedBy>Microsoft 帐户</cp:lastModifiedBy>
  <cp:revision>18</cp:revision>
  <dcterms:created xsi:type="dcterms:W3CDTF">2022-11-05T14:28:04Z</dcterms:created>
  <dcterms:modified xsi:type="dcterms:W3CDTF">2022-12-15T09:15:07Z</dcterms:modified>
</cp:coreProperties>
</file>